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80" r:id="rId2"/>
    <p:sldId id="381" r:id="rId3"/>
  </p:sldIdLst>
  <p:sldSz cx="6858000" cy="9144000" type="screen4x3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EBCB7FD-A07A-495C-8F4B-EC31AD5C0319}">
          <p14:sldIdLst>
            <p14:sldId id="380"/>
            <p14:sldId id="38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16" autoAdjust="0"/>
    <p:restoredTop sz="92791" autoAdjust="0"/>
  </p:normalViewPr>
  <p:slideViewPr>
    <p:cSldViewPr snapToGrid="0">
      <p:cViewPr varScale="1">
        <p:scale>
          <a:sx n="79" d="100"/>
          <a:sy n="79" d="100"/>
        </p:scale>
        <p:origin x="2760" y="6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700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526048-4AE9-457C-9937-D3EF5ADFF408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5050" y="1154113"/>
            <a:ext cx="23399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7" y="4445002"/>
            <a:ext cx="5559425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700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959D81-E8E8-4AFE-B382-D545514DA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077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888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720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130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905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600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381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516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088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321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465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358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2C771-4D36-4C12-89CE-67436A41516C}" type="datetimeFigureOut">
              <a:rPr lang="en-US" smtClean="0"/>
              <a:t>3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920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C6EC76-F222-7B57-A26D-167426F899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F11A6453-3AE2-07EF-E00B-8BBCE98517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01758" y="2557268"/>
            <a:ext cx="5829300" cy="1960033"/>
          </a:xfrm>
        </p:spPr>
        <p:txBody>
          <a:bodyPr>
            <a:norm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utologous mitochondrial transplantation enhances the bioenergetics of auditory cells and mitigates cell loss induced by H₂O₂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1E299EE1-FC65-DDF1-B3C8-F184D508177A}"/>
              </a:ext>
            </a:extLst>
          </p:cNvPr>
          <p:cNvSpPr txBox="1">
            <a:spLocks/>
          </p:cNvSpPr>
          <p:nvPr/>
        </p:nvSpPr>
        <p:spPr>
          <a:xfrm>
            <a:off x="514350" y="1577252"/>
            <a:ext cx="5829300" cy="19600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Suppl. Figures </a:t>
            </a:r>
            <a:endParaRPr lang="da-DK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353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3E2B857-5434-C13A-E875-F527E3D73C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8E770A18-7F7C-B3E5-5824-EDE284B155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0545" y="548821"/>
            <a:ext cx="3349752" cy="22783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E50AAAA-0ACD-E867-4CE1-DA11185771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5282" y="3211513"/>
            <a:ext cx="3352800" cy="228447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BCB6F64-A947-E1A6-73BE-72E87FF14E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52515" y="3130844"/>
            <a:ext cx="3349752" cy="227838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ED18E16-B3CB-6C48-D074-81CB6BCA48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8363" y="597181"/>
            <a:ext cx="3483864" cy="22844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05BF39F-14BC-B2BC-FF7D-0E989A5B6828}"/>
              </a:ext>
            </a:extLst>
          </p:cNvPr>
          <p:cNvSpPr txBox="1"/>
          <p:nvPr/>
        </p:nvSpPr>
        <p:spPr>
          <a:xfrm rot="10800000" flipV="1">
            <a:off x="1334895" y="475656"/>
            <a:ext cx="10972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ptos (Body)"/>
                <a:ea typeface="Calibri" panose="020F0502020204030204" pitchFamily="34" charset="0"/>
                <a:cs typeface="Times New Roman" panose="02020603050405020304" pitchFamily="18" charset="0"/>
              </a:rPr>
              <a:t>HEIOC1 growth </a:t>
            </a:r>
            <a:endParaRPr lang="en-US" sz="800" dirty="0">
              <a:solidFill>
                <a:srgbClr val="7030A0"/>
              </a:solidFill>
              <a:latin typeface="Aptos (Body)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170C32C-FE3C-9589-A353-841DBEF73D94}"/>
              </a:ext>
            </a:extLst>
          </p:cNvPr>
          <p:cNvSpPr/>
          <p:nvPr/>
        </p:nvSpPr>
        <p:spPr>
          <a:xfrm>
            <a:off x="-42211" y="-7725"/>
            <a:ext cx="2710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AFCC9D-3CD6-2BB6-9C69-B0EFBC119728}"/>
              </a:ext>
            </a:extLst>
          </p:cNvPr>
          <p:cNvSpPr txBox="1"/>
          <p:nvPr/>
        </p:nvSpPr>
        <p:spPr>
          <a:xfrm>
            <a:off x="-45043" y="361607"/>
            <a:ext cx="4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9FB58F7-7AEB-2D85-BFC6-7C3473B2F1DA}"/>
              </a:ext>
            </a:extLst>
          </p:cNvPr>
          <p:cNvSpPr txBox="1"/>
          <p:nvPr/>
        </p:nvSpPr>
        <p:spPr>
          <a:xfrm>
            <a:off x="-45043" y="2801737"/>
            <a:ext cx="4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E4CF522-997A-CB98-B4E7-3E96E67F56FB}"/>
              </a:ext>
            </a:extLst>
          </p:cNvPr>
          <p:cNvSpPr txBox="1"/>
          <p:nvPr/>
        </p:nvSpPr>
        <p:spPr>
          <a:xfrm>
            <a:off x="3256853" y="361607"/>
            <a:ext cx="4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621A0E7-2969-A01C-839E-19B72BC768FA}"/>
              </a:ext>
            </a:extLst>
          </p:cNvPr>
          <p:cNvSpPr txBox="1"/>
          <p:nvPr/>
        </p:nvSpPr>
        <p:spPr>
          <a:xfrm>
            <a:off x="3256853" y="2801737"/>
            <a:ext cx="4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0B78EC-A88B-8E73-9CEC-38AD4D6509F4}"/>
              </a:ext>
            </a:extLst>
          </p:cNvPr>
          <p:cNvSpPr txBox="1"/>
          <p:nvPr/>
        </p:nvSpPr>
        <p:spPr>
          <a:xfrm rot="10800000" flipV="1">
            <a:off x="1339521" y="3047958"/>
            <a:ext cx="10972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ptos (Body)"/>
                <a:ea typeface="Calibri" panose="020F0502020204030204" pitchFamily="34" charset="0"/>
                <a:cs typeface="Times New Roman" panose="02020603050405020304" pitchFamily="18" charset="0"/>
              </a:rPr>
              <a:t>HEIOC1 growth </a:t>
            </a:r>
            <a:endParaRPr lang="en-US" sz="800" dirty="0">
              <a:solidFill>
                <a:srgbClr val="7030A0"/>
              </a:solidFill>
              <a:latin typeface="Aptos (Body)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101CDD-9FF5-90AA-76C0-05C98935D71F}"/>
              </a:ext>
            </a:extLst>
          </p:cNvPr>
          <p:cNvSpPr txBox="1"/>
          <p:nvPr/>
        </p:nvSpPr>
        <p:spPr>
          <a:xfrm rot="10800000" flipV="1">
            <a:off x="4729316" y="3047958"/>
            <a:ext cx="10972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ptos (Body)"/>
                <a:ea typeface="Calibri" panose="020F0502020204030204" pitchFamily="34" charset="0"/>
                <a:cs typeface="Times New Roman" panose="02020603050405020304" pitchFamily="18" charset="0"/>
              </a:rPr>
              <a:t>HEIOC1 growth </a:t>
            </a:r>
            <a:endParaRPr lang="en-US" sz="1000" dirty="0">
              <a:solidFill>
                <a:srgbClr val="7030A0"/>
              </a:solidFill>
              <a:latin typeface="Aptos (Body)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BAA7EC-9432-82AF-FA85-B175B692E23D}"/>
              </a:ext>
            </a:extLst>
          </p:cNvPr>
          <p:cNvSpPr txBox="1"/>
          <p:nvPr/>
        </p:nvSpPr>
        <p:spPr>
          <a:xfrm rot="10800000" flipV="1">
            <a:off x="4729316" y="475655"/>
            <a:ext cx="109727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ptos (Body)"/>
                <a:ea typeface="Calibri" panose="020F0502020204030204" pitchFamily="34" charset="0"/>
                <a:cs typeface="Times New Roman" panose="02020603050405020304" pitchFamily="18" charset="0"/>
              </a:rPr>
              <a:t>HEIOC1 growth </a:t>
            </a:r>
            <a:endParaRPr lang="en-US" sz="1000" dirty="0">
              <a:solidFill>
                <a:srgbClr val="7030A0"/>
              </a:solidFill>
              <a:latin typeface="Aptos (Body)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1519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340</TotalTime>
  <Words>41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 (Body)</vt:lpstr>
      <vt:lpstr>Arial</vt:lpstr>
      <vt:lpstr>Calibri</vt:lpstr>
      <vt:lpstr>Office Theme</vt:lpstr>
      <vt:lpstr>Autologous mitochondrial transplantation enhances the bioenergetics of auditory cells and mitigates cell loss induced by H₂O₂</vt:lpstr>
      <vt:lpstr>PowerPoint Presentation</vt:lpstr>
    </vt:vector>
  </TitlesOfParts>
  <Company>N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venson, Elayne (NIH/NIA/IRP) [F]</dc:creator>
  <cp:lastModifiedBy>Arash Kheradvar</cp:lastModifiedBy>
  <cp:revision>1082</cp:revision>
  <cp:lastPrinted>2020-01-16T20:00:03Z</cp:lastPrinted>
  <dcterms:created xsi:type="dcterms:W3CDTF">2016-06-13T15:22:18Z</dcterms:created>
  <dcterms:modified xsi:type="dcterms:W3CDTF">2025-03-23T16:15:05Z</dcterms:modified>
</cp:coreProperties>
</file>